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5620"/>
    <p:restoredTop sz="99061" autoAdjust="0"/>
  </p:normalViewPr>
  <p:slideViewPr>
    <p:cSldViewPr snapToGrid="0" snapToObjects="1" showGuides="1">
      <p:cViewPr>
        <p:scale>
          <a:sx n="100" d="100"/>
          <a:sy n="100" d="100"/>
        </p:scale>
        <p:origin x="-249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C5190-F970-6C48-944A-3E836B2EAB59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F2F6B8-6550-C948-BBBA-F1829B55B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>
            <a:grpSpLocks noChangeAspect="1"/>
          </p:cNvGrpSpPr>
          <p:nvPr/>
        </p:nvGrpSpPr>
        <p:grpSpPr>
          <a:xfrm>
            <a:off x="1306799" y="2758496"/>
            <a:ext cx="4025818" cy="3622889"/>
            <a:chOff x="1442271" y="599496"/>
            <a:chExt cx="3705786" cy="3334889"/>
          </a:xfrm>
        </p:grpSpPr>
        <p:pic>
          <p:nvPicPr>
            <p:cNvPr id="4" name="Picture 3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43343" y="2428659"/>
              <a:ext cx="1431785" cy="1339411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54199" y="2483804"/>
              <a:ext cx="1481158" cy="1385598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1537323" y="2407192"/>
              <a:ext cx="277721" cy="143282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32407" y="3364865"/>
              <a:ext cx="302730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0</a:t>
              </a:r>
              <a:endParaRPr lang="en-US" sz="7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583530" y="3169921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20</a:t>
              </a:r>
              <a:endParaRPr lang="en-US" sz="7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583530" y="2977410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0</a:t>
              </a:r>
              <a:endParaRPr lang="en-US" sz="7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88123" y="2793327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</a:t>
              </a:r>
              <a:endParaRPr lang="en-US" sz="7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586885" y="2600364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80</a:t>
              </a:r>
              <a:endParaRPr lang="en-US" sz="7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42930" y="2425230"/>
              <a:ext cx="412035" cy="25666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</a:rPr>
                <a:t>100</a:t>
              </a:r>
              <a:endParaRPr lang="en-US" sz="700" dirty="0">
                <a:solidFill>
                  <a:srgbClr val="000000"/>
                </a:solidFill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3586392" y="2501565"/>
              <a:ext cx="277721" cy="143282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691653" y="3427616"/>
              <a:ext cx="302730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0</a:t>
              </a:r>
              <a:endParaRPr lang="en-US" sz="7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648207" y="3238102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20</a:t>
              </a:r>
              <a:endParaRPr lang="en-US" sz="7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648207" y="3051022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0</a:t>
              </a:r>
              <a:endParaRPr lang="en-US" sz="7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652800" y="2866939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</a:t>
              </a:r>
              <a:endParaRPr lang="en-US" sz="7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46131" y="2684838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80</a:t>
              </a:r>
              <a:endParaRPr lang="en-US" sz="7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614125" y="2477119"/>
              <a:ext cx="412035" cy="25666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</a:rPr>
                <a:t>100</a:t>
              </a:r>
              <a:endParaRPr lang="en-US" sz="700" dirty="0">
                <a:solidFill>
                  <a:srgbClr val="000000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3180077" y="2740954"/>
              <a:ext cx="812829" cy="276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unts (%)</a:t>
              </a:r>
              <a:endParaRPr lang="en-US" sz="800" dirty="0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3129929" y="2016725"/>
              <a:ext cx="1339433" cy="31360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98152" y="798871"/>
              <a:ext cx="1431594" cy="1339410"/>
            </a:xfrm>
            <a:prstGeom prst="rect">
              <a:avLst/>
            </a:prstGeom>
          </p:spPr>
        </p:pic>
        <p:grpSp>
          <p:nvGrpSpPr>
            <p:cNvPr id="23" name="Group 22"/>
            <p:cNvGrpSpPr>
              <a:grpSpLocks/>
            </p:cNvGrpSpPr>
            <p:nvPr/>
          </p:nvGrpSpPr>
          <p:grpSpPr>
            <a:xfrm>
              <a:off x="1565571" y="746141"/>
              <a:ext cx="1518721" cy="1305723"/>
              <a:chOff x="637690" y="2660654"/>
              <a:chExt cx="1496000" cy="1334520"/>
            </a:xfrm>
          </p:grpSpPr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37690" y="2660654"/>
                <a:ext cx="1496000" cy="1330287"/>
              </a:xfrm>
              <a:prstGeom prst="rect">
                <a:avLst/>
              </a:prstGeom>
            </p:spPr>
          </p:pic>
          <p:sp>
            <p:nvSpPr>
              <p:cNvPr id="25" name="Rectangle 24"/>
              <p:cNvSpPr/>
              <p:nvPr/>
            </p:nvSpPr>
            <p:spPr>
              <a:xfrm>
                <a:off x="930275" y="3746500"/>
                <a:ext cx="1074685" cy="24867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6" name="Rectangle 25"/>
            <p:cNvSpPr/>
            <p:nvPr/>
          </p:nvSpPr>
          <p:spPr>
            <a:xfrm>
              <a:off x="1539184" y="803168"/>
              <a:ext cx="277721" cy="143282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633583" y="1647758"/>
              <a:ext cx="302730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0</a:t>
              </a:r>
              <a:endParaRPr lang="en-US" sz="7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590137" y="1452814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20</a:t>
              </a:r>
              <a:endParaRPr lang="en-US" sz="7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90137" y="1271164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0</a:t>
              </a:r>
              <a:endParaRPr lang="en-US" sz="7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589299" y="1097943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</a:t>
              </a:r>
              <a:endParaRPr lang="en-US" sz="7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582630" y="904980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80</a:t>
              </a:r>
              <a:endParaRPr lang="en-US" sz="7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544106" y="724415"/>
              <a:ext cx="412035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0</a:t>
              </a:r>
              <a:endParaRPr lang="en-US" sz="700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1176217" y="1040493"/>
              <a:ext cx="812829" cy="276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unts (%)</a:t>
              </a:r>
              <a:endParaRPr 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059273" y="599496"/>
              <a:ext cx="59548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CONTROL</a:t>
              </a:r>
              <a:endParaRPr lang="en-US" sz="800" b="1" dirty="0">
                <a:solidFill>
                  <a:srgbClr val="000000"/>
                </a:solidFill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611124" y="865954"/>
              <a:ext cx="277721" cy="143282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732677" y="1721405"/>
              <a:ext cx="302730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0</a:t>
              </a:r>
              <a:endParaRPr lang="en-US" sz="7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683800" y="1537322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20</a:t>
              </a:r>
              <a:endParaRPr lang="en-US" sz="7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683800" y="1350242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40</a:t>
              </a:r>
              <a:endParaRPr lang="en-US" sz="7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682962" y="1160728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60</a:t>
              </a:r>
              <a:endParaRPr lang="en-US" sz="7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676293" y="973197"/>
              <a:ext cx="353663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80</a:t>
              </a:r>
              <a:endParaRPr lang="en-US" sz="7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632338" y="781770"/>
              <a:ext cx="412035" cy="25666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700" dirty="0" smtClean="0">
                  <a:solidFill>
                    <a:srgbClr val="000000"/>
                  </a:solidFill>
                </a:rPr>
                <a:t>100</a:t>
              </a:r>
              <a:endParaRPr lang="en-US" sz="700" dirty="0">
                <a:solidFill>
                  <a:srgbClr val="000000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3269978" y="1056966"/>
              <a:ext cx="812829" cy="276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unts (%)</a:t>
              </a:r>
              <a:endParaRPr lang="en-US" sz="8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163762" y="633515"/>
              <a:ext cx="60350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SOX10 KD</a:t>
              </a:r>
              <a:endParaRPr lang="en-US" sz="800" b="1" dirty="0">
                <a:solidFill>
                  <a:srgbClr val="000000"/>
                </a:solidFill>
              </a:endParaRPr>
            </a:p>
          </p:txBody>
        </p:sp>
        <p:sp>
          <p:nvSpPr>
            <p:cNvPr id="45" name="Rectangle 44"/>
            <p:cNvSpPr/>
            <p:nvPr/>
          </p:nvSpPr>
          <p:spPr>
            <a:xfrm>
              <a:off x="3968688" y="1896736"/>
              <a:ext cx="1038567" cy="188847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853514" y="1812628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0</a:t>
              </a:r>
              <a:endParaRPr lang="en-US" sz="7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095093" y="1816430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1</a:t>
              </a:r>
              <a:endParaRPr lang="en-US" sz="7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319616" y="1813959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2</a:t>
              </a:r>
              <a:endParaRPr lang="en-US" sz="7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556121" y="1815435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3</a:t>
              </a:r>
              <a:endParaRPr lang="en-US" sz="7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755480" y="1815029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4</a:t>
              </a:r>
              <a:endParaRPr lang="en-US" sz="7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161924" y="1912899"/>
              <a:ext cx="70833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 smtClean="0"/>
                <a:t>Annexin</a:t>
              </a:r>
              <a:r>
                <a:rPr lang="en-US" sz="700" dirty="0" smtClean="0"/>
                <a:t> V</a:t>
              </a:r>
              <a:endParaRPr lang="en-US" sz="700" dirty="0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1841423" y="1827495"/>
              <a:ext cx="1038567" cy="188847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780557" y="1743386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0</a:t>
              </a:r>
              <a:endParaRPr lang="en-US" sz="7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967828" y="1747189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1</a:t>
              </a:r>
              <a:endParaRPr lang="en-US" sz="7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192351" y="1744718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2</a:t>
              </a:r>
              <a:endParaRPr lang="en-US" sz="7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428856" y="1746193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3</a:t>
              </a:r>
              <a:endParaRPr lang="en-US" sz="7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628215" y="1745788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4</a:t>
              </a:r>
              <a:endParaRPr lang="en-US" sz="7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034659" y="1843657"/>
              <a:ext cx="70833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 smtClean="0"/>
                <a:t>Annexin</a:t>
              </a:r>
              <a:r>
                <a:rPr lang="en-US" sz="700" dirty="0" smtClean="0"/>
                <a:t> V</a:t>
              </a:r>
              <a:endParaRPr lang="en-US" sz="700" dirty="0"/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1174059" y="2715529"/>
              <a:ext cx="812829" cy="2764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unts (%)</a:t>
              </a:r>
              <a:endParaRPr lang="en-US" sz="8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070057" y="2277680"/>
              <a:ext cx="55015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SOX9 OE</a:t>
              </a:r>
              <a:endParaRPr lang="en-US" sz="800" b="1" dirty="0">
                <a:solidFill>
                  <a:srgbClr val="000000"/>
                </a:solidFill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860218" y="3528323"/>
              <a:ext cx="1038567" cy="188847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745044" y="3444215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0</a:t>
              </a:r>
              <a:endParaRPr lang="en-US" sz="7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986623" y="3448018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1</a:t>
              </a:r>
              <a:endParaRPr lang="en-US" sz="7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211146" y="3445547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2</a:t>
              </a:r>
              <a:endParaRPr lang="en-US" sz="7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447651" y="3447022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3</a:t>
              </a:r>
              <a:endParaRPr lang="en-US" sz="700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647009" y="3446617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4</a:t>
              </a:r>
              <a:endParaRPr lang="en-US" sz="7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053453" y="3544486"/>
              <a:ext cx="70833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 smtClean="0"/>
                <a:t>Annexin</a:t>
              </a:r>
              <a:r>
                <a:rPr lang="en-US" sz="700" dirty="0" smtClean="0"/>
                <a:t> V</a:t>
              </a:r>
              <a:endParaRPr lang="en-US" sz="700" dirty="0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936094" y="3603419"/>
              <a:ext cx="1084752" cy="188847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820922" y="3519311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0</a:t>
              </a:r>
              <a:endParaRPr lang="en-US" sz="7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062501" y="3523113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1</a:t>
              </a:r>
              <a:endParaRPr lang="en-US" sz="7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287024" y="3520642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2</a:t>
              </a:r>
              <a:endParaRPr lang="en-US" sz="7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523529" y="3522118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3</a:t>
              </a:r>
              <a:endParaRPr lang="en-US" sz="7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722887" y="3521712"/>
              <a:ext cx="39257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10</a:t>
              </a:r>
              <a:r>
                <a:rPr lang="en-US" sz="700" baseline="30000" dirty="0" smtClean="0"/>
                <a:t>4</a:t>
              </a:r>
              <a:endParaRPr lang="en-US" sz="7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129332" y="3619582"/>
              <a:ext cx="708337" cy="256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 smtClean="0"/>
                <a:t>Annexin</a:t>
              </a:r>
              <a:r>
                <a:rPr lang="en-US" sz="700" dirty="0" smtClean="0"/>
                <a:t> V</a:t>
              </a:r>
              <a:endParaRPr lang="en-US" sz="7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984263" y="2339862"/>
              <a:ext cx="1016725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rgbClr val="000000"/>
                  </a:solidFill>
                </a:rPr>
                <a:t>SOX10 KD  SOX9 KD</a:t>
              </a:r>
              <a:endParaRPr lang="en-US" sz="800" b="1" dirty="0">
                <a:solidFill>
                  <a:srgbClr val="000000"/>
                </a:solidFill>
              </a:endParaRPr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1548501" y="6384711"/>
            <a:ext cx="16712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5</a:t>
            </a:r>
          </a:p>
          <a:p>
            <a:endParaRPr lang="en-US" sz="1200" dirty="0"/>
          </a:p>
        </p:txBody>
      </p:sp>
      <p:sp>
        <p:nvSpPr>
          <p:cNvPr id="76" name="TextBox 75"/>
          <p:cNvSpPr txBox="1"/>
          <p:nvPr/>
        </p:nvSpPr>
        <p:spPr>
          <a:xfrm>
            <a:off x="5085799" y="-32764"/>
            <a:ext cx="17852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Shakhova</a:t>
            </a:r>
            <a:r>
              <a:rPr lang="en-US" sz="900" dirty="0" smtClean="0"/>
              <a:t> et </a:t>
            </a:r>
            <a:r>
              <a:rPr lang="en-US" sz="900" dirty="0" err="1" smtClean="0"/>
              <a:t>al_Supplemental</a:t>
            </a:r>
            <a:r>
              <a:rPr lang="en-US" sz="900" dirty="0" smtClean="0"/>
              <a:t> Fig5</a:t>
            </a:r>
            <a:endParaRPr lang="en-US" sz="900" dirty="0"/>
          </a:p>
        </p:txBody>
      </p:sp>
      <p:sp>
        <p:nvSpPr>
          <p:cNvPr id="78" name="TextBox 77"/>
          <p:cNvSpPr txBox="1"/>
          <p:nvPr/>
        </p:nvSpPr>
        <p:spPr>
          <a:xfrm>
            <a:off x="999200" y="1264218"/>
            <a:ext cx="2885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  <p:pic>
        <p:nvPicPr>
          <p:cNvPr id="79" name="Picture 78" descr="Simon 1.tiff"/>
          <p:cNvPicPr>
            <a:picLocks/>
          </p:cNvPicPr>
          <p:nvPr/>
        </p:nvPicPr>
        <p:blipFill>
          <a:blip r:embed="rId6">
            <a:lum bright="11000"/>
          </a:blip>
          <a:stretch>
            <a:fillRect/>
          </a:stretch>
        </p:blipFill>
        <p:spPr>
          <a:xfrm>
            <a:off x="1744225" y="1520028"/>
            <a:ext cx="1123490" cy="795063"/>
          </a:xfrm>
          <a:prstGeom prst="rect">
            <a:avLst/>
          </a:prstGeom>
        </p:spPr>
      </p:pic>
      <p:sp>
        <p:nvSpPr>
          <p:cNvPr id="83" name="Textfeld 11"/>
          <p:cNvSpPr txBox="1"/>
          <p:nvPr/>
        </p:nvSpPr>
        <p:spPr>
          <a:xfrm>
            <a:off x="1307603" y="1972124"/>
            <a:ext cx="8159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 smtClean="0"/>
              <a:t>ACTIN</a:t>
            </a:r>
            <a:endParaRPr lang="de-CH" sz="1000" dirty="0"/>
          </a:p>
        </p:txBody>
      </p:sp>
      <p:sp>
        <p:nvSpPr>
          <p:cNvPr id="84" name="TextBox 83"/>
          <p:cNvSpPr txBox="1"/>
          <p:nvPr/>
        </p:nvSpPr>
        <p:spPr>
          <a:xfrm>
            <a:off x="1801788" y="1320647"/>
            <a:ext cx="422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ntrl</a:t>
            </a:r>
            <a:endParaRPr lang="en-US" sz="1000" dirty="0"/>
          </a:p>
        </p:txBody>
      </p:sp>
      <p:sp>
        <p:nvSpPr>
          <p:cNvPr id="87" name="TextBox 86"/>
          <p:cNvSpPr txBox="1"/>
          <p:nvPr/>
        </p:nvSpPr>
        <p:spPr>
          <a:xfrm>
            <a:off x="2214255" y="1338687"/>
            <a:ext cx="6976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OX10 KD</a:t>
            </a:r>
            <a:endParaRPr lang="en-US" sz="1000" dirty="0"/>
          </a:p>
        </p:txBody>
      </p:sp>
      <p:pic>
        <p:nvPicPr>
          <p:cNvPr id="85" name="Picture 84" descr="Simon 2.tiff"/>
          <p:cNvPicPr>
            <a:picLocks/>
          </p:cNvPicPr>
          <p:nvPr/>
        </p:nvPicPr>
        <p:blipFill>
          <a:blip r:embed="rId7">
            <a:lum bright="20000"/>
          </a:blip>
          <a:stretch>
            <a:fillRect/>
          </a:stretch>
        </p:blipFill>
        <p:spPr>
          <a:xfrm>
            <a:off x="4048504" y="1526793"/>
            <a:ext cx="1060809" cy="805718"/>
          </a:xfrm>
          <a:prstGeom prst="rect">
            <a:avLst/>
          </a:prstGeom>
        </p:spPr>
      </p:pic>
      <p:sp>
        <p:nvSpPr>
          <p:cNvPr id="86" name="Textfeld 4"/>
          <p:cNvSpPr txBox="1"/>
          <p:nvPr/>
        </p:nvSpPr>
        <p:spPr>
          <a:xfrm>
            <a:off x="3676137" y="1568029"/>
            <a:ext cx="628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 smtClean="0"/>
              <a:t>SOX9</a:t>
            </a:r>
            <a:endParaRPr lang="de-CH" sz="1000" dirty="0"/>
          </a:p>
        </p:txBody>
      </p:sp>
      <p:sp>
        <p:nvSpPr>
          <p:cNvPr id="88" name="TextBox 87"/>
          <p:cNvSpPr txBox="1"/>
          <p:nvPr/>
        </p:nvSpPr>
        <p:spPr>
          <a:xfrm>
            <a:off x="4100677" y="1339311"/>
            <a:ext cx="422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ntrl</a:t>
            </a:r>
            <a:endParaRPr lang="en-US" sz="1000" dirty="0"/>
          </a:p>
        </p:txBody>
      </p:sp>
      <p:sp>
        <p:nvSpPr>
          <p:cNvPr id="89" name="TextBox 88"/>
          <p:cNvSpPr txBox="1"/>
          <p:nvPr/>
        </p:nvSpPr>
        <p:spPr>
          <a:xfrm>
            <a:off x="4480520" y="1355930"/>
            <a:ext cx="6976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SOX10 KD</a:t>
            </a:r>
            <a:endParaRPr lang="en-US" sz="1000" dirty="0"/>
          </a:p>
        </p:txBody>
      </p:sp>
      <p:sp>
        <p:nvSpPr>
          <p:cNvPr id="90" name="Textfeld 11"/>
          <p:cNvSpPr txBox="1"/>
          <p:nvPr/>
        </p:nvSpPr>
        <p:spPr>
          <a:xfrm>
            <a:off x="3642697" y="1958410"/>
            <a:ext cx="778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 smtClean="0"/>
              <a:t>ACTIN</a:t>
            </a:r>
            <a:endParaRPr lang="de-CH" sz="1000" dirty="0"/>
          </a:p>
        </p:txBody>
      </p:sp>
      <p:sp>
        <p:nvSpPr>
          <p:cNvPr id="91" name="TextBox 90"/>
          <p:cNvSpPr txBox="1"/>
          <p:nvPr/>
        </p:nvSpPr>
        <p:spPr>
          <a:xfrm>
            <a:off x="1026819" y="2586426"/>
            <a:ext cx="2823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94" name="Rectangle 93"/>
          <p:cNvSpPr/>
          <p:nvPr/>
        </p:nvSpPr>
        <p:spPr>
          <a:xfrm>
            <a:off x="1674299" y="1526793"/>
            <a:ext cx="89128" cy="342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Textfeld 4"/>
          <p:cNvSpPr txBox="1"/>
          <p:nvPr/>
        </p:nvSpPr>
        <p:spPr>
          <a:xfrm>
            <a:off x="1298270" y="1570561"/>
            <a:ext cx="6590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dirty="0" smtClean="0"/>
              <a:t>SOX10</a:t>
            </a:r>
            <a:endParaRPr lang="de-CH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9</TotalTime>
  <Words>96</Words>
  <Application>Microsoft Macintosh PowerPoint</Application>
  <PresentationFormat>On-screen Show (4:3)</PresentationFormat>
  <Paragraphs>68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 Shakhova</dc:creator>
  <cp:lastModifiedBy>Olga Shakhova</cp:lastModifiedBy>
  <cp:revision>6</cp:revision>
  <dcterms:created xsi:type="dcterms:W3CDTF">2014-09-16T12:51:23Z</dcterms:created>
  <dcterms:modified xsi:type="dcterms:W3CDTF">2014-09-16T13:13:14Z</dcterms:modified>
</cp:coreProperties>
</file>